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65" r:id="rId3"/>
    <p:sldId id="264" r:id="rId4"/>
  </p:sldIdLst>
  <p:sldSz cx="12192000" cy="6858000"/>
  <p:notesSz cx="6858000" cy="9144000"/>
  <p:embeddedFontLst>
    <p:embeddedFont>
      <p:font typeface="맑은 고딕" panose="020B0503020000020004" pitchFamily="34" charset="-127"/>
      <p:regular r:id="rId6"/>
      <p:bold r:id="rId7"/>
    </p:embeddedFont>
    <p:embeddedFont>
      <p:font typeface="Palatino Linotype" panose="02040502050505030304" pitchFamily="18" charset="0"/>
      <p:regular r:id="rId8"/>
      <p:bold r:id="rId9"/>
      <p:italic r:id="rId10"/>
      <p:boldItalic r:id="rId11"/>
    </p:embeddedFont>
  </p:embeddedFont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43" autoAdjust="0"/>
    <p:restoredTop sz="92414" autoAdjust="0"/>
  </p:normalViewPr>
  <p:slideViewPr>
    <p:cSldViewPr snapToGrid="0">
      <p:cViewPr varScale="1">
        <p:scale>
          <a:sx n="105" d="100"/>
          <a:sy n="105" d="100"/>
        </p:scale>
        <p:origin x="7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font" Target="fonts/font6.fntdata"/><Relationship Id="rId5" Type="http://schemas.openxmlformats.org/officeDocument/2006/relationships/notesMaster" Target="notesMasters/notesMaster1.xml"/><Relationship Id="rId15" Type="http://schemas.openxmlformats.org/officeDocument/2006/relationships/tableStyles" Target="tableStyles.xml"/><Relationship Id="rId10" Type="http://schemas.openxmlformats.org/officeDocument/2006/relationships/font" Target="fonts/font5.fntdata"/><Relationship Id="rId4" Type="http://schemas.openxmlformats.org/officeDocument/2006/relationships/slide" Target="slides/slide3.xml"/><Relationship Id="rId9" Type="http://schemas.openxmlformats.org/officeDocument/2006/relationships/font" Target="fonts/font4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9510A0-8536-4058-B2E8-AF3256F819CC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CD3179-EA83-45E4-A2D7-8A0415A84C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5193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EDF7F1-96C7-7BC3-4BFE-5A126D7BBE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F68148D-F6B4-B301-CD49-C965EE0421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C1FA480-9960-DAF7-7932-C71F628E3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B06E26B-C100-F969-5BD1-E6823A978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B7C5CB-C5EA-07D2-98AF-C852D0681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510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EF3B44-0072-EF09-C89C-70CC01DF9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796FD4F-E619-9EE8-819F-3F7C6FBC3A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5208D2C-0616-094C-CA9C-DB2AF496E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E859B4D-2966-E4B5-10B2-D3293C3FA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D886909-DCD6-F29C-D6FA-9E2484C59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3345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57729BD-E47C-5033-EC7A-E37A314323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FED97DB-6DC4-4041-C84A-187DFD5A70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C703200-30CC-CA9C-FEC5-3DB3A3E0C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3BD8A55-25F6-2390-013F-61F5CEE71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88C556F-7D7D-78B2-12FC-F89DE0513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5686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784DE88-51EF-35B9-A38D-BCCB50A58B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986DF00-65FC-3DC4-9BC9-99BBBC5BC9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2043BEB-322C-F74F-6E3E-93D3D0DE1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D4E8E45-D654-E882-F135-2ED3BEB11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B5F8A77-FE9E-3F34-8EC5-CBC07403D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320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6B88F3D-D719-6522-7906-9C9B39D64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A26CC2A-1918-BAD2-75F6-2D40FE375B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D1C7EA2-D8E6-5C79-D631-66E9F1CB0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A9C32D5-EF31-2BD7-7010-FDC1215B8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733D80-DB8D-CB24-6FD4-9D4C07AFA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0509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E6876EA-07DD-2FF3-DB54-CFE702E22B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A013C31-329D-9274-4411-A668E7723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C89192B-F792-284C-A6C3-3E158E32D8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0E41178-602F-7DD5-669D-34AA0C30D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082987D-E9A8-5425-254B-5FB0E9F9C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0147753-8F0E-9D43-28CC-3D075530E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3152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E061D1-B745-B7D6-4B03-AB9194026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D5F8682-7F5C-4608-705A-8D721CD87A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A8E94BB-CBC8-AA07-A454-CFBAE55030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F9A3E90-26D1-3158-BF05-946A14BF8F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69FE855-DCE6-8292-9A96-D1035336F5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853382B-2A6F-E28F-F29A-BD2A5C079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3501D5C-6D64-AD2E-38AB-7BB8E1ED9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B9B29E0-F81A-1007-060D-F8EF337B5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3645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8745DD-0CD8-7CF5-722D-DF077BBAA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D77C99A-C693-A90F-B897-299E080AD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8BEB24E-7B37-94F3-B48B-92A183529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F6734754-5E9B-9D16-D994-0ED01A17F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307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02E27F4-7FD1-F15E-BA57-390890286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91A6D04-BD99-8E8C-95DF-872455C3E0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58BD015-3AAB-904B-FF23-B3FD032E6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1603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6FC886-6FCF-B60E-C6FC-3F9DB0024E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9C5F353-8745-3DF1-184E-970A253497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AD596E9-F13D-3256-21B2-562DE6055F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29583F1-626E-9117-99C2-B571532BD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CF5729A-0C18-CA04-EE24-337C2E47B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9305B83-5215-D3F8-D358-D57DAF5FF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2846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88C0F6-2F5F-A427-AF04-67BB1A0D8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4195DDB7-F286-125C-DEF0-4A9F9C4EC9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839FDC8-9316-552F-CA52-1CBDE9DD2E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3DF0096-9CB3-078E-873F-8190D777E8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2F43B8B-FA34-2B3E-171F-BA3A962FE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23127AE-C2B5-45E7-C316-D226D5AA8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6142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FFF393F-05A0-3608-5915-494CD10C34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8C2490E-7CBF-49D4-E078-1D626584C2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5B27937-842F-E565-E4E4-DC365DCC39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7C718A-1E23-49FB-8265-9323CE0282B4}" type="datetimeFigureOut">
              <a:rPr lang="ko-KR" altLang="en-US" smtClean="0"/>
              <a:t>2024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047A852-9DD9-B523-8AFD-D1044F5B508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0B8A7CA-E540-FC15-557F-770DF93FD8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D193E12-60EB-4A72-8C3D-21767C935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2440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4ED102-D52F-B504-BB54-A4F570BE55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2599762"/>
            <a:ext cx="9144000" cy="2387600"/>
          </a:xfrm>
        </p:spPr>
        <p:txBody>
          <a:bodyPr anchor="ctr" anchorCtr="0"/>
          <a:lstStyle/>
          <a:p>
            <a:r>
              <a:rPr lang="en-US" altLang="ko-KR" b="1" i="1" dirty="0">
                <a:latin typeface="Palatino Linotype" panose="02040502050505030304" pitchFamily="18" charset="0"/>
              </a:rPr>
              <a:t>Supplementary</a:t>
            </a:r>
            <a:endParaRPr lang="ko-KR" altLang="en-US" b="1" i="1" dirty="0">
              <a:latin typeface="Palatino Linotype" panose="02040502050505030304" pitchFamily="18" charset="0"/>
            </a:endParaRPr>
          </a:p>
        </p:txBody>
      </p:sp>
      <p:pic>
        <p:nvPicPr>
          <p:cNvPr id="5" name="그림 4" descr="텍스트, 그래픽 디자인, 그래픽, 실루엣이(가) 표시된 사진&#10;&#10;자동 생성된 설명">
            <a:extLst>
              <a:ext uri="{FF2B5EF4-FFF2-40B4-BE49-F238E27FC236}">
                <a16:creationId xmlns:a16="http://schemas.microsoft.com/office/drawing/2014/main" id="{E947299A-E869-FB78-C171-E0F638C1C4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084"/>
          <a:stretch/>
        </p:blipFill>
        <p:spPr>
          <a:xfrm>
            <a:off x="0" y="1"/>
            <a:ext cx="2136716" cy="720000"/>
          </a:xfrm>
          <a:prstGeom prst="rect">
            <a:avLst/>
          </a:prstGeom>
        </p:spPr>
      </p:pic>
      <p:pic>
        <p:nvPicPr>
          <p:cNvPr id="7" name="그림 6" descr="폰트, 그래픽, 로고, 상징이(가) 표시된 사진&#10;&#10;자동 생성된 설명">
            <a:extLst>
              <a:ext uri="{FF2B5EF4-FFF2-40B4-BE49-F238E27FC236}">
                <a16:creationId xmlns:a16="http://schemas.microsoft.com/office/drawing/2014/main" id="{EDEBA8BC-9CA9-053A-0AA8-D45C88A720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0357"/>
          <a:stretch/>
        </p:blipFill>
        <p:spPr>
          <a:xfrm>
            <a:off x="11081596" y="0"/>
            <a:ext cx="1110404" cy="720000"/>
          </a:xfrm>
          <a:prstGeom prst="rect">
            <a:avLst/>
          </a:prstGeom>
        </p:spPr>
      </p:pic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7E06D365-635F-7B6D-DACF-3ECD8CA064BC}"/>
              </a:ext>
            </a:extLst>
          </p:cNvPr>
          <p:cNvCxnSpPr/>
          <p:nvPr/>
        </p:nvCxnSpPr>
        <p:spPr>
          <a:xfrm>
            <a:off x="0" y="728546"/>
            <a:ext cx="121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34434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텍스트, 그래픽 디자인, 그래픽, 실루엣이(가) 표시된 사진&#10;&#10;자동 생성된 설명">
            <a:extLst>
              <a:ext uri="{FF2B5EF4-FFF2-40B4-BE49-F238E27FC236}">
                <a16:creationId xmlns:a16="http://schemas.microsoft.com/office/drawing/2014/main" id="{B461658F-3C90-1CDB-237D-2312977712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084"/>
          <a:stretch/>
        </p:blipFill>
        <p:spPr>
          <a:xfrm>
            <a:off x="0" y="1"/>
            <a:ext cx="2136716" cy="720000"/>
          </a:xfrm>
          <a:prstGeom prst="rect">
            <a:avLst/>
          </a:prstGeom>
        </p:spPr>
      </p:pic>
      <p:pic>
        <p:nvPicPr>
          <p:cNvPr id="17" name="그림 16" descr="폰트, 그래픽, 로고, 상징이(가) 표시된 사진&#10;&#10;자동 생성된 설명">
            <a:extLst>
              <a:ext uri="{FF2B5EF4-FFF2-40B4-BE49-F238E27FC236}">
                <a16:creationId xmlns:a16="http://schemas.microsoft.com/office/drawing/2014/main" id="{CD9AAA4B-0247-6ADD-62C1-BE29EBCAB0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0357"/>
          <a:stretch/>
        </p:blipFill>
        <p:spPr>
          <a:xfrm>
            <a:off x="11081596" y="0"/>
            <a:ext cx="1110404" cy="720000"/>
          </a:xfrm>
          <a:prstGeom prst="rect">
            <a:avLst/>
          </a:prstGeom>
        </p:spPr>
      </p:pic>
      <p:sp>
        <p:nvSpPr>
          <p:cNvPr id="19" name="제목 1">
            <a:extLst>
              <a:ext uri="{FF2B5EF4-FFF2-40B4-BE49-F238E27FC236}">
                <a16:creationId xmlns:a16="http://schemas.microsoft.com/office/drawing/2014/main" id="{828AFAC0-85DE-13AA-6B29-93A085E992C9}"/>
              </a:ext>
            </a:extLst>
          </p:cNvPr>
          <p:cNvSpPr txBox="1">
            <a:spLocks/>
          </p:cNvSpPr>
          <p:nvPr/>
        </p:nvSpPr>
        <p:spPr>
          <a:xfrm>
            <a:off x="0" y="741600"/>
            <a:ext cx="12192000" cy="1008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US" altLang="ko-KR" sz="4000" dirty="0">
                <a:latin typeface="Palatino Linotype" panose="02040502050505030304" pitchFamily="18" charset="0"/>
              </a:rPr>
              <a:t>Supplementary S1.</a:t>
            </a:r>
          </a:p>
          <a:p>
            <a:pPr>
              <a:lnSpc>
                <a:spcPct val="100000"/>
              </a:lnSpc>
            </a:pPr>
            <a:r>
              <a:rPr lang="en-US" altLang="ko-KR" sz="28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맑은 고딕" panose="020B0503020000020004" pitchFamily="50" charset="-127"/>
              </a:rPr>
              <a:t>VIP AMC MSC Therapy Consent Form</a:t>
            </a:r>
            <a:r>
              <a:rPr lang="en-US" altLang="ko-KR" sz="2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.</a:t>
            </a:r>
            <a:endParaRPr lang="ko-KR" altLang="en-US" sz="2800" dirty="0">
              <a:latin typeface="Palatino Linotype" panose="02040502050505030304" pitchFamily="18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607DF707-20F6-1BB4-A824-44C14F892BCF}"/>
              </a:ext>
            </a:extLst>
          </p:cNvPr>
          <p:cNvCxnSpPr/>
          <p:nvPr/>
        </p:nvCxnSpPr>
        <p:spPr>
          <a:xfrm>
            <a:off x="0" y="728546"/>
            <a:ext cx="121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" name="그림 4">
            <a:extLst>
              <a:ext uri="{FF2B5EF4-FFF2-40B4-BE49-F238E27FC236}">
                <a16:creationId xmlns:a16="http://schemas.microsoft.com/office/drawing/2014/main" id="{DDFB9D4D-F3CB-743C-DB8A-9EC7040FBBD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83531" y="762492"/>
            <a:ext cx="4482315" cy="608545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4912741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텍스트, 그래픽 디자인, 그래픽, 실루엣이(가) 표시된 사진&#10;&#10;자동 생성된 설명">
            <a:extLst>
              <a:ext uri="{FF2B5EF4-FFF2-40B4-BE49-F238E27FC236}">
                <a16:creationId xmlns:a16="http://schemas.microsoft.com/office/drawing/2014/main" id="{B461658F-3C90-1CDB-237D-2312977712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6084"/>
          <a:stretch/>
        </p:blipFill>
        <p:spPr>
          <a:xfrm>
            <a:off x="0" y="1"/>
            <a:ext cx="2136716" cy="720000"/>
          </a:xfrm>
          <a:prstGeom prst="rect">
            <a:avLst/>
          </a:prstGeom>
        </p:spPr>
      </p:pic>
      <p:pic>
        <p:nvPicPr>
          <p:cNvPr id="17" name="그림 16" descr="폰트, 그래픽, 로고, 상징이(가) 표시된 사진&#10;&#10;자동 생성된 설명">
            <a:extLst>
              <a:ext uri="{FF2B5EF4-FFF2-40B4-BE49-F238E27FC236}">
                <a16:creationId xmlns:a16="http://schemas.microsoft.com/office/drawing/2014/main" id="{CD9AAA4B-0247-6ADD-62C1-BE29EBCAB0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0357"/>
          <a:stretch/>
        </p:blipFill>
        <p:spPr>
          <a:xfrm>
            <a:off x="11081596" y="0"/>
            <a:ext cx="1110404" cy="720000"/>
          </a:xfrm>
          <a:prstGeom prst="rect">
            <a:avLst/>
          </a:prstGeom>
        </p:spPr>
      </p:pic>
      <p:graphicFrame>
        <p:nvGraphicFramePr>
          <p:cNvPr id="6" name="표 5">
            <a:extLst>
              <a:ext uri="{FF2B5EF4-FFF2-40B4-BE49-F238E27FC236}">
                <a16:creationId xmlns:a16="http://schemas.microsoft.com/office/drawing/2014/main" id="{FCCF3832-DA89-CDCB-3441-BE28FF19C7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4789646"/>
              </p:ext>
            </p:extLst>
          </p:nvPr>
        </p:nvGraphicFramePr>
        <p:xfrm>
          <a:off x="374627" y="1915940"/>
          <a:ext cx="11253893" cy="44240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5944">
                  <a:extLst>
                    <a:ext uri="{9D8B030D-6E8A-4147-A177-3AD203B41FA5}">
                      <a16:colId xmlns:a16="http://schemas.microsoft.com/office/drawing/2014/main" val="1738411356"/>
                    </a:ext>
                  </a:extLst>
                </a:gridCol>
                <a:gridCol w="863601">
                  <a:extLst>
                    <a:ext uri="{9D8B030D-6E8A-4147-A177-3AD203B41FA5}">
                      <a16:colId xmlns:a16="http://schemas.microsoft.com/office/drawing/2014/main" val="3893218108"/>
                    </a:ext>
                  </a:extLst>
                </a:gridCol>
                <a:gridCol w="628650">
                  <a:extLst>
                    <a:ext uri="{9D8B030D-6E8A-4147-A177-3AD203B41FA5}">
                      <a16:colId xmlns:a16="http://schemas.microsoft.com/office/drawing/2014/main" val="3041431794"/>
                    </a:ext>
                  </a:extLst>
                </a:gridCol>
                <a:gridCol w="600868">
                  <a:extLst>
                    <a:ext uri="{9D8B030D-6E8A-4147-A177-3AD203B41FA5}">
                      <a16:colId xmlns:a16="http://schemas.microsoft.com/office/drawing/2014/main" val="3625843232"/>
                    </a:ext>
                  </a:extLst>
                </a:gridCol>
                <a:gridCol w="665584">
                  <a:extLst>
                    <a:ext uri="{9D8B030D-6E8A-4147-A177-3AD203B41FA5}">
                      <a16:colId xmlns:a16="http://schemas.microsoft.com/office/drawing/2014/main" val="2724602369"/>
                    </a:ext>
                  </a:extLst>
                </a:gridCol>
                <a:gridCol w="1068970">
                  <a:extLst>
                    <a:ext uri="{9D8B030D-6E8A-4147-A177-3AD203B41FA5}">
                      <a16:colId xmlns:a16="http://schemas.microsoft.com/office/drawing/2014/main" val="495135812"/>
                    </a:ext>
                  </a:extLst>
                </a:gridCol>
                <a:gridCol w="1068970">
                  <a:extLst>
                    <a:ext uri="{9D8B030D-6E8A-4147-A177-3AD203B41FA5}">
                      <a16:colId xmlns:a16="http://schemas.microsoft.com/office/drawing/2014/main" val="1871730533"/>
                    </a:ext>
                  </a:extLst>
                </a:gridCol>
                <a:gridCol w="930025">
                  <a:extLst>
                    <a:ext uri="{9D8B030D-6E8A-4147-A177-3AD203B41FA5}">
                      <a16:colId xmlns:a16="http://schemas.microsoft.com/office/drawing/2014/main" val="3027158021"/>
                    </a:ext>
                  </a:extLst>
                </a:gridCol>
                <a:gridCol w="667824">
                  <a:extLst>
                    <a:ext uri="{9D8B030D-6E8A-4147-A177-3AD203B41FA5}">
                      <a16:colId xmlns:a16="http://schemas.microsoft.com/office/drawing/2014/main" val="694606332"/>
                    </a:ext>
                  </a:extLst>
                </a:gridCol>
                <a:gridCol w="934508">
                  <a:extLst>
                    <a:ext uri="{9D8B030D-6E8A-4147-A177-3AD203B41FA5}">
                      <a16:colId xmlns:a16="http://schemas.microsoft.com/office/drawing/2014/main" val="1432544324"/>
                    </a:ext>
                  </a:extLst>
                </a:gridCol>
                <a:gridCol w="597401">
                  <a:extLst>
                    <a:ext uri="{9D8B030D-6E8A-4147-A177-3AD203B41FA5}">
                      <a16:colId xmlns:a16="http://schemas.microsoft.com/office/drawing/2014/main" val="215987818"/>
                    </a:ext>
                  </a:extLst>
                </a:gridCol>
                <a:gridCol w="793750">
                  <a:extLst>
                    <a:ext uri="{9D8B030D-6E8A-4147-A177-3AD203B41FA5}">
                      <a16:colId xmlns:a16="http://schemas.microsoft.com/office/drawing/2014/main" val="3022279908"/>
                    </a:ext>
                  </a:extLst>
                </a:gridCol>
                <a:gridCol w="692150">
                  <a:extLst>
                    <a:ext uri="{9D8B030D-6E8A-4147-A177-3AD203B41FA5}">
                      <a16:colId xmlns:a16="http://schemas.microsoft.com/office/drawing/2014/main" val="3890156760"/>
                    </a:ext>
                  </a:extLst>
                </a:gridCol>
                <a:gridCol w="647700">
                  <a:extLst>
                    <a:ext uri="{9D8B030D-6E8A-4147-A177-3AD203B41FA5}">
                      <a16:colId xmlns:a16="http://schemas.microsoft.com/office/drawing/2014/main" val="2247879631"/>
                    </a:ext>
                  </a:extLst>
                </a:gridCol>
                <a:gridCol w="517948">
                  <a:extLst>
                    <a:ext uri="{9D8B030D-6E8A-4147-A177-3AD203B41FA5}">
                      <a16:colId xmlns:a16="http://schemas.microsoft.com/office/drawing/2014/main" val="4539705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atient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Bree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Gende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g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Body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weight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Disea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tegori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Specif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disea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el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rigi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el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sourc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ell do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r>
                        <a:rPr lang="en-US" sz="700" kern="0" baseline="30000" dirty="0">
                          <a:effectLst/>
                          <a:latin typeface="Palatino Linotype" panose="02040502050505030304" pitchFamily="18" charset="0"/>
                        </a:rPr>
                        <a:t>6</a:t>
                      </a: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 cells/kg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Rout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assag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Tota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treatment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session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ver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effects scor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herapeutic outcom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627860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Yorkshir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Terrie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9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5.2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Rena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CK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404246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alte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9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5.6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rthopedic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OA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4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812934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oodl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3.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phthalm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PRA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68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530699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oodl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2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Rena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K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654975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5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alte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7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rthopedic/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Neurolog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D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50089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6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Weimarane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8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2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rthoped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A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153216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7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ixe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7.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rthopedic/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Neuro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DD, OA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192486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8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hihuahua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.6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Renal/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rdiovascula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CK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13358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D9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altese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Renal/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rdiovascula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KD, MMV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.9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10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669103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GD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Long coat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hihuahua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9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4.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rdia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MV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.98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591290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2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Welsh Corgi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1.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Neuro/Rena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DD, OA,</a:t>
                      </a: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roteinuria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O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3.9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78196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Pomeranian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8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3.9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rdiovascula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MV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O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.9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686573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4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Cocker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Spaniel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1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6.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rdiovascular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MV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204024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5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Maltese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7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2.5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Cardiovascular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MVD, CD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.98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6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90222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6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Long coat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Chihuahua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8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2.6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Cardia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MV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O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.03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611652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7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Beagle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1.8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Neuro/Rena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KD, IVDD, DJ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T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0.99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9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95300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GD8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Maltese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Renal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K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TD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388756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GD9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Long coat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hihuahua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N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9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2.9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ardia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MMV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T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>
                          <a:effectLst/>
                          <a:latin typeface="Palatino Linotype" panose="02040502050505030304" pitchFamily="18" charset="0"/>
                        </a:rPr>
                        <a:t>1.03</a:t>
                      </a:r>
                      <a:endParaRPr lang="ko-KR" sz="700" kern="10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6350" marR="6350" marT="635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997532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GD1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oodle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FS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5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4.6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Orthopedic/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Renal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CCLR, MPL, CK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Allogeneic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TD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.0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IV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P4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700" kern="0" dirty="0">
                          <a:effectLst/>
                          <a:latin typeface="Palatino Linotype" panose="02040502050505030304" pitchFamily="18" charset="0"/>
                        </a:rPr>
                        <a:t>12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altLang="ko-KR" sz="700" kern="0" dirty="0"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  <a:endParaRPr lang="ko-KR" sz="700" kern="100" dirty="0">
                        <a:effectLst/>
                        <a:latin typeface="Palatino Linotype" panose="0204050205050503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6350" marR="6350" marT="635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3258274"/>
                  </a:ext>
                </a:extLst>
              </a:tr>
            </a:tbl>
          </a:graphicData>
        </a:graphic>
      </p:graphicFrame>
      <p:cxnSp>
        <p:nvCxnSpPr>
          <p:cNvPr id="2" name="직선 연결선 1">
            <a:extLst>
              <a:ext uri="{FF2B5EF4-FFF2-40B4-BE49-F238E27FC236}">
                <a16:creationId xmlns:a16="http://schemas.microsoft.com/office/drawing/2014/main" id="{3DC27D61-C017-3DCC-9E4C-75553541A697}"/>
              </a:ext>
            </a:extLst>
          </p:cNvPr>
          <p:cNvCxnSpPr/>
          <p:nvPr/>
        </p:nvCxnSpPr>
        <p:spPr>
          <a:xfrm>
            <a:off x="0" y="728546"/>
            <a:ext cx="121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A1616174-370B-13B6-EF8F-98606DBDAEBE}"/>
              </a:ext>
            </a:extLst>
          </p:cNvPr>
          <p:cNvSpPr txBox="1"/>
          <p:nvPr/>
        </p:nvSpPr>
        <p:spPr>
          <a:xfrm>
            <a:off x="128899" y="6387772"/>
            <a:ext cx="11934202" cy="4259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altLang="ko-KR" sz="1050" kern="1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MVD= myxomatous mitral valve disease; CKD= chronic kidney disease; IVDD= intervertebral disk disease; CDS= cognitive dysfunction syndrome; DJD= degenerative joint disease; OA= osteoarthritis; MPL= medial patellar luxation; CCLR= cranial cruciate ligament rupture; PRA= Progressive Retinal Atrophy; </a:t>
            </a:r>
            <a:r>
              <a:rPr lang="en-US" altLang="ko-KR" sz="1050" kern="1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D=adipose tissue-derived;</a:t>
            </a:r>
            <a:r>
              <a:rPr lang="ko-KR" altLang="en-US" sz="1050" kern="1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050" kern="100" dirty="0">
                <a:solidFill>
                  <a:srgbClr val="000000"/>
                </a:solidFill>
                <a:highlight>
                  <a:srgbClr val="FFFF00"/>
                </a:highlight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D= ovary-derived; TD= testis-derived; IV=intravenous.</a:t>
            </a:r>
            <a:endParaRPr lang="ko-KR" altLang="en-US" dirty="0"/>
          </a:p>
        </p:txBody>
      </p:sp>
      <p:sp>
        <p:nvSpPr>
          <p:cNvPr id="7" name="제목 1">
            <a:extLst>
              <a:ext uri="{FF2B5EF4-FFF2-40B4-BE49-F238E27FC236}">
                <a16:creationId xmlns:a16="http://schemas.microsoft.com/office/drawing/2014/main" id="{828AFAC0-85DE-13AA-6B29-93A085E992C9}"/>
              </a:ext>
            </a:extLst>
          </p:cNvPr>
          <p:cNvSpPr txBox="1">
            <a:spLocks/>
          </p:cNvSpPr>
          <p:nvPr/>
        </p:nvSpPr>
        <p:spPr>
          <a:xfrm>
            <a:off x="0" y="741600"/>
            <a:ext cx="12192000" cy="9576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00000"/>
              </a:lnSpc>
            </a:pPr>
            <a:r>
              <a:rPr lang="en-US" altLang="ko-KR" sz="4000">
                <a:latin typeface="Palatino Linotype" panose="02040502050505030304" pitchFamily="18" charset="0"/>
              </a:rPr>
              <a:t>Supplementary S2</a:t>
            </a:r>
            <a:r>
              <a:rPr lang="en-US" altLang="ko-KR" sz="4000" dirty="0">
                <a:latin typeface="Palatino Linotype" panose="02040502050505030304" pitchFamily="18" charset="0"/>
              </a:rPr>
              <a:t>. </a:t>
            </a:r>
          </a:p>
          <a:p>
            <a:pPr>
              <a:lnSpc>
                <a:spcPct val="100000"/>
              </a:lnSpc>
            </a:pPr>
            <a:r>
              <a:rPr lang="en-US" altLang="ko-KR" sz="24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Palatino Linotype" panose="02040502050505030304" pitchFamily="18" charset="0"/>
                <a:ea typeface="맑은 고딕" panose="020B0503020000020004" pitchFamily="50" charset="-127"/>
              </a:rPr>
              <a:t>Patients’ information for canine gonadal and adipose tissue-derived MSC therapy</a:t>
            </a:r>
            <a:endParaRPr lang="ko-KR" altLang="en-US" sz="2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233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</TotalTime>
  <Words>452</Words>
  <Application>Microsoft Office PowerPoint</Application>
  <PresentationFormat>Widescreen</PresentationFormat>
  <Paragraphs>32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Palatino Linotype</vt:lpstr>
      <vt:lpstr>맑은 고딕</vt:lpstr>
      <vt:lpstr>Arial</vt:lpstr>
      <vt:lpstr>Times New Roman</vt:lpstr>
      <vt:lpstr>Office 테마</vt:lpstr>
      <vt:lpstr>Supplementary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DPI supplementary</dc:title>
  <dc:creator>정소영</dc:creator>
  <cp:lastModifiedBy>MDPI</cp:lastModifiedBy>
  <cp:revision>31</cp:revision>
  <dcterms:created xsi:type="dcterms:W3CDTF">2024-05-10T09:11:03Z</dcterms:created>
  <dcterms:modified xsi:type="dcterms:W3CDTF">2024-07-22T07:06:19Z</dcterms:modified>
</cp:coreProperties>
</file>